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95687"/>
  </p:normalViewPr>
  <p:slideViewPr>
    <p:cSldViewPr snapToGrid="0" snapToObjects="1">
      <p:cViewPr varScale="1">
        <p:scale>
          <a:sx n="102" d="100"/>
          <a:sy n="102" d="100"/>
        </p:scale>
        <p:origin x="41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AFF0B39-AE68-BC4D-AE3C-BF3F4CDA94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4FD040E-597C-8A4B-847A-E960A37722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A710313-03E7-C048-AC56-6A7DD277E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B5F93-24CD-E64B-9027-9A24B267F085}" type="datetimeFigureOut">
              <a:rPr kumimoji="1" lang="zh-CN" altLang="en-US" smtClean="0"/>
              <a:t>2024/7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3F4C2DF-3C3C-C44E-9DA6-53D7D02EB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B9DFD0B-8BA6-1244-B6E1-267BD7F66F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DF322-11BD-0C46-9DA9-FD92FCFAA7F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241739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3277D0-852A-B44B-BF83-8A26F6ABA2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62E06A2-264A-F44F-B7F1-0F8A412251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C5CF4F0-D029-3E45-A6A4-D5D7966557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B5F93-24CD-E64B-9027-9A24B267F085}" type="datetimeFigureOut">
              <a:rPr kumimoji="1" lang="zh-CN" altLang="en-US" smtClean="0"/>
              <a:t>2024/7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12E0FA1-0198-574C-A7D9-CEC09E07E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14F061D-A009-6443-8AAC-C1BAF63C2F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DF322-11BD-0C46-9DA9-FD92FCFAA7F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14524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8CE7222-3334-4C4E-B28F-8D0F000E98D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ECCDA4A-3504-1441-B46A-8642E94BBB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C42CDD-9157-D74E-A2C8-AFE8C63327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B5F93-24CD-E64B-9027-9A24B267F085}" type="datetimeFigureOut">
              <a:rPr kumimoji="1" lang="zh-CN" altLang="en-US" smtClean="0"/>
              <a:t>2024/7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3A4B43-0327-E249-BF9E-3288E7A47D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43DE66F-CF53-2B4E-8842-363030D43A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DF322-11BD-0C46-9DA9-FD92FCFAA7F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62540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F0B43E-75A9-3844-9B5F-53BFFE5EDF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B398BEB-BE20-6D43-8B89-877DFD826E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F0920E-4C2D-5F48-9C6C-FACBEFCF86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B5F93-24CD-E64B-9027-9A24B267F085}" type="datetimeFigureOut">
              <a:rPr kumimoji="1" lang="zh-CN" altLang="en-US" smtClean="0"/>
              <a:t>2024/7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1ED210-3794-E04D-BF10-3D2267B7E4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CD0D75-4B07-FC44-9C41-52CED889E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DF322-11BD-0C46-9DA9-FD92FCFAA7F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9159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BE207E7-45D7-B94E-82D2-E7FBB35D05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E7F705F-7838-5543-90BC-221D29C13A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4AE9A53-E7C4-B643-841A-BF9DFFFF5E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B5F93-24CD-E64B-9027-9A24B267F085}" type="datetimeFigureOut">
              <a:rPr kumimoji="1" lang="zh-CN" altLang="en-US" smtClean="0"/>
              <a:t>2024/7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1CCF21-A11A-094F-83C8-14EDD1317A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CF75078-19F2-F84C-8CC5-997ACF79A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DF322-11BD-0C46-9DA9-FD92FCFAA7F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55908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317DAB-5B6B-574B-84E8-596BBCCF58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283C692-CFBC-BB4C-8784-334DEEFEEC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CBF5B1D-3DD6-9847-A7B6-383A796408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79D8209-816E-8647-BAC2-7E52F91D0A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B5F93-24CD-E64B-9027-9A24B267F085}" type="datetimeFigureOut">
              <a:rPr kumimoji="1" lang="zh-CN" altLang="en-US" smtClean="0"/>
              <a:t>2024/7/1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7DFD20C-9532-7640-966D-2909604DE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ACF95F8-EC85-A54D-96A0-EF07F75EDD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DF322-11BD-0C46-9DA9-FD92FCFAA7F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78351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119EB5-CEF1-7B4F-A396-3B47E801DC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FE54A1F-A5A7-1640-9D60-B2A69A4674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C419E57-F827-A849-84A0-A349B979EE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CC57674-7628-1946-9936-8073142D0E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252884C-D569-584B-B890-1051CA3BB4F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28F3500-B5F3-0948-96D1-594D498354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B5F93-24CD-E64B-9027-9A24B267F085}" type="datetimeFigureOut">
              <a:rPr kumimoji="1" lang="zh-CN" altLang="en-US" smtClean="0"/>
              <a:t>2024/7/17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1780F6E-C962-3E41-91F2-ED17227F5E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F2D3433-55D1-5F44-BDDC-8E34C5F8D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DF322-11BD-0C46-9DA9-FD92FCFAA7F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71060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FD8743-1C16-1543-A28E-7024EF324B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1F2FE1C-088D-9F47-8638-BB599A441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B5F93-24CD-E64B-9027-9A24B267F085}" type="datetimeFigureOut">
              <a:rPr kumimoji="1" lang="zh-CN" altLang="en-US" smtClean="0"/>
              <a:t>2024/7/17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A99D9C3-9A5F-6440-9F67-FBB196BF58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5FB26C4-1B7E-0549-A261-2BBC54964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DF322-11BD-0C46-9DA9-FD92FCFAA7F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06797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7E63E9F-DA29-B247-BD7B-97157DDF25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B5F93-24CD-E64B-9027-9A24B267F085}" type="datetimeFigureOut">
              <a:rPr kumimoji="1" lang="zh-CN" altLang="en-US" smtClean="0"/>
              <a:t>2024/7/17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F238433-7BE2-AA4C-95F6-E6CA576EEF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BDB6ACC-4811-5B45-B2CE-60DD61626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DF322-11BD-0C46-9DA9-FD92FCFAA7F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3286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C5A28B-8BF3-7C4A-B45B-7B48D70190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D9BA7F0-A74E-F041-9EA6-46F346C2F3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FD969D6-F5CE-6649-882E-2E346189A0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5F28ECB-4CBA-244F-B4FB-81D2942652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B5F93-24CD-E64B-9027-9A24B267F085}" type="datetimeFigureOut">
              <a:rPr kumimoji="1" lang="zh-CN" altLang="en-US" smtClean="0"/>
              <a:t>2024/7/1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399AACD-5590-F24E-96B1-3CE8CCAC7D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D4AE7AD-8D04-0148-B98F-7DD22892D2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DF322-11BD-0C46-9DA9-FD92FCFAA7F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008008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733D3D-F8F7-1A46-A481-5E80E9BDCE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4B3B760-5262-B64B-AF79-B8985F1BAF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6C71B97-B805-E24A-A697-250AFE6B36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6401923-65BB-5244-8BF8-5C3DADAD6E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B5F93-24CD-E64B-9027-9A24B267F085}" type="datetimeFigureOut">
              <a:rPr kumimoji="1" lang="zh-CN" altLang="en-US" smtClean="0"/>
              <a:t>2024/7/1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FC7A060-69FB-1144-B675-088E6784A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0B5F293-CC63-004C-B4A0-327701B0D4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DF322-11BD-0C46-9DA9-FD92FCFAA7F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425310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8B059B3-5075-234C-8AE4-82DBF0DDCF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CFE2E3A-B808-2E4B-9154-0F9802455D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E396828-2898-2145-AB43-BA89EA72E4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FB5F93-24CD-E64B-9027-9A24B267F085}" type="datetimeFigureOut">
              <a:rPr kumimoji="1" lang="zh-CN" altLang="en-US" smtClean="0"/>
              <a:t>2024/7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79F66F-DD2A-064E-A3B0-F5A0BF358C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6840A93-C5A3-8E4D-B7FA-535980557F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8DF322-11BD-0C46-9DA9-FD92FCFAA7F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33835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F16239E1-02BE-B64C-A227-BABB610586E9}"/>
              </a:ext>
            </a:extLst>
          </p:cNvPr>
          <p:cNvSpPr/>
          <p:nvPr/>
        </p:nvSpPr>
        <p:spPr>
          <a:xfrm>
            <a:off x="718159" y="620689"/>
            <a:ext cx="1063042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deo S1. Incucyte real-time monitoring the proliferation of hAECs with the addition of SB431542.</a:t>
            </a:r>
          </a:p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Cell proliferation video of passage P1 hAECs under seeding density of 2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×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</a:t>
            </a:r>
            <a:r>
              <a:rPr lang="zh-CN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m². </a:t>
            </a:r>
          </a:p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Impact of adding 1μM SB431542 on the cell proliferation of passage P1 under seeding density of 2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×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</a:t>
            </a:r>
            <a:r>
              <a:rPr lang="zh-CN" alt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m².</a:t>
            </a:r>
          </a:p>
          <a:p>
            <a:endParaRPr lang="zh-CN" altLang="en-US" dirty="0"/>
          </a:p>
        </p:txBody>
      </p:sp>
      <p:pic>
        <p:nvPicPr>
          <p:cNvPr id="5" name="9e20f478899dc29eb19741386f9343c8_720497486766_v_1698804686776912">
            <a:hlinkClick r:id="" action="ppaction://media"/>
            <a:extLst>
              <a:ext uri="{FF2B5EF4-FFF2-40B4-BE49-F238E27FC236}">
                <a16:creationId xmlns:a16="http://schemas.microsoft.com/office/drawing/2014/main" id="{CB32C8B9-C1F2-5645-AD7B-4AE7E96F6882}"/>
              </a:ext>
            </a:extLst>
          </p:cNvPr>
          <p:cNvPicPr/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2277114" y="2748412"/>
            <a:ext cx="3896498" cy="2892527"/>
          </a:xfrm>
          <a:prstGeom prst="rect">
            <a:avLst/>
          </a:prstGeom>
        </p:spPr>
      </p:pic>
      <p:pic>
        <p:nvPicPr>
          <p:cNvPr id="6" name="9e20f478899dc29eb19741386f9343c8_720497566720_v_1698804766726196">
            <a:hlinkClick r:id="" action="ppaction://media"/>
            <a:extLst>
              <a:ext uri="{FF2B5EF4-FFF2-40B4-BE49-F238E27FC236}">
                <a16:creationId xmlns:a16="http://schemas.microsoft.com/office/drawing/2014/main" id="{90119851-763B-4345-83F9-7051D1FE9AD5}"/>
              </a:ext>
            </a:extLst>
          </p:cNvPr>
          <p:cNvPicPr/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218698" y="2748412"/>
            <a:ext cx="3985401" cy="2892527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AC164733-5426-9942-83C2-632C46D1A59E}"/>
              </a:ext>
            </a:extLst>
          </p:cNvPr>
          <p:cNvSpPr txBox="1"/>
          <p:nvPr/>
        </p:nvSpPr>
        <p:spPr>
          <a:xfrm>
            <a:off x="2277114" y="2328976"/>
            <a:ext cx="389649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B431542-0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A7A809E-7B2A-C647-8F0C-9003520B3A6A}"/>
              </a:ext>
            </a:extLst>
          </p:cNvPr>
          <p:cNvSpPr txBox="1"/>
          <p:nvPr/>
        </p:nvSpPr>
        <p:spPr>
          <a:xfrm>
            <a:off x="6218698" y="2328976"/>
            <a:ext cx="396600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B431542-1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3940149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>
                <p:cTn id="2" fill="hold" display="1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video>
              <p:cMediaNode>
                <p:cTn id="3" fill="hold" display="1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65</Words>
  <Application>Microsoft Macintosh PowerPoint</Application>
  <PresentationFormat>宽屏</PresentationFormat>
  <Paragraphs>5</Paragraphs>
  <Slides>1</Slides>
  <Notes>0</Notes>
  <HiddenSlides>0</HiddenSlides>
  <MMClips>2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WP</dc:creator>
  <cp:lastModifiedBy>HWP</cp:lastModifiedBy>
  <cp:revision>2</cp:revision>
  <dcterms:created xsi:type="dcterms:W3CDTF">2024-07-17T14:05:44Z</dcterms:created>
  <dcterms:modified xsi:type="dcterms:W3CDTF">2024-07-17T14:12:10Z</dcterms:modified>
</cp:coreProperties>
</file>